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43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TNF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2tnf_A  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2tnf_A 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142852"/>
            <a:ext cx="3500462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142852"/>
            <a:ext cx="3643338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5720" y="3143248"/>
            <a:ext cx="3500462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214686"/>
            <a:ext cx="3643338" cy="278608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7</cp:revision>
  <dcterms:created xsi:type="dcterms:W3CDTF">2018-05-10T07:33:24Z</dcterms:created>
  <dcterms:modified xsi:type="dcterms:W3CDTF">2018-05-29T07:47:52Z</dcterms:modified>
</cp:coreProperties>
</file>